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22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1755" autoAdjust="0"/>
    <p:restoredTop sz="94660"/>
  </p:normalViewPr>
  <p:slideViewPr>
    <p:cSldViewPr snapToGrid="0" showGuides="1">
      <p:cViewPr varScale="1">
        <p:scale>
          <a:sx n="37" d="100"/>
          <a:sy n="37" d="100"/>
        </p:scale>
        <p:origin x="2502" y="66"/>
      </p:cViewPr>
      <p:guideLst>
        <p:guide orient="horz" pos="4322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B45C-2B9A-469D-A3CF-AA1DDC3FA1ED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AA976-7EA0-4DF4-8E21-5559736C6C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5028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B45C-2B9A-469D-A3CF-AA1DDC3FA1ED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AA976-7EA0-4DF4-8E21-5559736C6C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85577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B45C-2B9A-469D-A3CF-AA1DDC3FA1ED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AA976-7EA0-4DF4-8E21-5559736C6C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82078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B45C-2B9A-469D-A3CF-AA1DDC3FA1ED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AA976-7EA0-4DF4-8E21-5559736C6C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288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B45C-2B9A-469D-A3CF-AA1DDC3FA1ED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AA976-7EA0-4DF4-8E21-5559736C6C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1487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B45C-2B9A-469D-A3CF-AA1DDC3FA1ED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AA976-7EA0-4DF4-8E21-5559736C6C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9104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B45C-2B9A-469D-A3CF-AA1DDC3FA1ED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AA976-7EA0-4DF4-8E21-5559736C6C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2374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B45C-2B9A-469D-A3CF-AA1DDC3FA1ED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AA976-7EA0-4DF4-8E21-5559736C6C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962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B45C-2B9A-469D-A3CF-AA1DDC3FA1ED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AA976-7EA0-4DF4-8E21-5559736C6C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68418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B45C-2B9A-469D-A3CF-AA1DDC3FA1ED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AA976-7EA0-4DF4-8E21-5559736C6C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22430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2B45C-2B9A-469D-A3CF-AA1DDC3FA1ED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AA976-7EA0-4DF4-8E21-5559736C6C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9193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62B45C-2B9A-469D-A3CF-AA1DDC3FA1ED}" type="datetimeFigureOut">
              <a:rPr lang="en-GB" smtClean="0"/>
              <a:t>07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FAA976-7EA0-4DF4-8E21-5559736C6C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9989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Rounded Rectangle 31"/>
          <p:cNvSpPr/>
          <p:nvPr/>
        </p:nvSpPr>
        <p:spPr>
          <a:xfrm>
            <a:off x="564444" y="914400"/>
            <a:ext cx="5742370" cy="2020186"/>
          </a:xfrm>
          <a:prstGeom prst="roundRect">
            <a:avLst/>
          </a:prstGeom>
          <a:noFill/>
          <a:ln w="19050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aphicFrame>
        <p:nvGraphicFramePr>
          <p:cNvPr id="38" name="Table 3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99729157"/>
              </p:ext>
            </p:extLst>
          </p:nvPr>
        </p:nvGraphicFramePr>
        <p:xfrm>
          <a:off x="565341" y="5705277"/>
          <a:ext cx="5729136" cy="3489960"/>
        </p:xfrm>
        <a:graphic>
          <a:graphicData uri="http://schemas.openxmlformats.org/drawingml/2006/table">
            <a:tbl>
              <a:tblPr firstRow="1" bandRow="1">
                <a:tableStyleId>{69CF1AB2-1976-4502-BF36-3FF5EA218861}</a:tableStyleId>
              </a:tblPr>
              <a:tblGrid>
                <a:gridCol w="475637"/>
                <a:gridCol w="475637"/>
                <a:gridCol w="655322"/>
                <a:gridCol w="655324"/>
                <a:gridCol w="634184"/>
                <a:gridCol w="862971"/>
                <a:gridCol w="656687"/>
                <a:gridCol w="656687"/>
                <a:gridCol w="656687"/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lang="en-GB" sz="1100" dirty="0"/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VL</a:t>
                      </a:r>
                    </a:p>
                    <a:p>
                      <a:pPr algn="ctr"/>
                      <a:r>
                        <a:rPr lang="en-GB" sz="1100" dirty="0" smtClean="0"/>
                        <a:t>case</a:t>
                      </a:r>
                      <a:endParaRPr lang="en-GB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Non-VL case</a:t>
                      </a:r>
                      <a:endParaRPr lang="en-GB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Chagas disease</a:t>
                      </a:r>
                      <a:endParaRPr lang="en-GB" sz="1100" dirty="0"/>
                    </a:p>
                  </a:txBody>
                  <a:tcPr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Malaria</a:t>
                      </a:r>
                      <a:endParaRPr lang="en-GB" sz="1100" dirty="0"/>
                    </a:p>
                  </a:txBody>
                  <a:tcPr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Other </a:t>
                      </a:r>
                      <a:r>
                        <a:rPr lang="en-GB" sz="1100" dirty="0" err="1" smtClean="0"/>
                        <a:t>parasitoses</a:t>
                      </a:r>
                      <a:endParaRPr lang="en-GB" sz="1100" dirty="0"/>
                    </a:p>
                  </a:txBody>
                  <a:tcPr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Spanish Blood donors</a:t>
                      </a:r>
                      <a:endParaRPr lang="en-GB" sz="1100" dirty="0"/>
                    </a:p>
                  </a:txBody>
                  <a:tcPr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German Blood donors</a:t>
                      </a:r>
                      <a:endParaRPr lang="en-GB" sz="1100" dirty="0"/>
                    </a:p>
                  </a:txBody>
                  <a:tcPr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Belgian Blood</a:t>
                      </a:r>
                      <a:r>
                        <a:rPr lang="en-GB" sz="1100" baseline="0" dirty="0" smtClean="0"/>
                        <a:t> donors</a:t>
                      </a:r>
                      <a:endParaRPr lang="en-GB" sz="1100" dirty="0"/>
                    </a:p>
                  </a:txBody>
                  <a:tcPr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100" b="1" dirty="0" smtClean="0"/>
                        <a:t>rK39 ICT POS</a:t>
                      </a:r>
                      <a:endParaRPr lang="en-GB" sz="1100" b="1" dirty="0"/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110</a:t>
                      </a:r>
                      <a:endParaRPr lang="en-GB" sz="1100" dirty="0"/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100" b="1" dirty="0" smtClean="0"/>
                        <a:t>rK39 ICT NEG</a:t>
                      </a:r>
                      <a:endParaRPr lang="en-GB" sz="1100" b="1" dirty="0"/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31</a:t>
                      </a:r>
                      <a:endParaRPr lang="en-GB" sz="1100" dirty="0"/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64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1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4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7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42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3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0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100" b="1" dirty="0" smtClean="0"/>
                        <a:t>DAT POS</a:t>
                      </a:r>
                      <a:endParaRPr lang="en-GB" sz="1100" b="1" dirty="0"/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122</a:t>
                      </a:r>
                      <a:endParaRPr lang="en-GB" sz="1100" dirty="0"/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7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100" b="1" dirty="0" smtClean="0"/>
                        <a:t>DATNEG</a:t>
                      </a:r>
                      <a:endParaRPr lang="en-GB" sz="1100" b="1" dirty="0"/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19</a:t>
                      </a:r>
                      <a:endParaRPr lang="en-GB" sz="1100" dirty="0"/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27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1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3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5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42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3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0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100" b="1" dirty="0" smtClean="0"/>
                        <a:t>IFAT POS</a:t>
                      </a:r>
                      <a:endParaRPr lang="en-GB" sz="1100" b="1" dirty="0"/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112</a:t>
                      </a:r>
                      <a:endParaRPr lang="en-GB" sz="1100" dirty="0"/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5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100" b="1" dirty="0" smtClean="0"/>
                        <a:t>IFAT NEG</a:t>
                      </a:r>
                      <a:endParaRPr lang="en-GB" sz="1100" b="1" dirty="0"/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29</a:t>
                      </a:r>
                      <a:endParaRPr lang="en-GB" sz="1100" dirty="0"/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62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6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5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7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42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3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0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671664" y="1398701"/>
            <a:ext cx="2124697" cy="1277273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en-GB" sz="1100" b="1" dirty="0" smtClean="0"/>
              <a:t>VL suspect cases (N=405)</a:t>
            </a:r>
          </a:p>
          <a:p>
            <a:r>
              <a:rPr lang="en-GB" sz="1100" dirty="0" smtClean="0"/>
              <a:t>With a VL diagnosis based on serological and parasitological methods.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/>
              <a:t>With enough serum volume available for the study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/>
              <a:t>With information on HIV status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902149" y="1419117"/>
            <a:ext cx="2404665" cy="938719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en-GB" sz="1100" b="1" dirty="0" smtClean="0"/>
              <a:t>Control groups (N=338)</a:t>
            </a:r>
          </a:p>
          <a:p>
            <a:r>
              <a:rPr lang="en-GB" sz="1100" dirty="0" smtClean="0"/>
              <a:t>Different diseases and healthy endemic and non-endemic control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dirty="0" smtClean="0"/>
              <a:t>With enough serum volume available for the study</a:t>
            </a:r>
          </a:p>
        </p:txBody>
      </p:sp>
      <p:sp>
        <p:nvSpPr>
          <p:cNvPr id="5" name="Rounded Rectangle 4"/>
          <p:cNvSpPr/>
          <p:nvPr/>
        </p:nvSpPr>
        <p:spPr>
          <a:xfrm>
            <a:off x="661032" y="1365903"/>
            <a:ext cx="2135330" cy="1398561"/>
          </a:xfrm>
          <a:prstGeom prst="roundRect">
            <a:avLst/>
          </a:prstGeom>
          <a:noFill/>
          <a:ln w="190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Rounded Rectangle 5"/>
          <p:cNvSpPr/>
          <p:nvPr/>
        </p:nvSpPr>
        <p:spPr>
          <a:xfrm>
            <a:off x="3902149" y="1364438"/>
            <a:ext cx="2307265" cy="1045681"/>
          </a:xfrm>
          <a:prstGeom prst="roundRect">
            <a:avLst/>
          </a:prstGeom>
          <a:noFill/>
          <a:ln w="1905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6138505"/>
              </p:ext>
            </p:extLst>
          </p:nvPr>
        </p:nvGraphicFramePr>
        <p:xfrm>
          <a:off x="1020726" y="3429000"/>
          <a:ext cx="5284728" cy="965200"/>
        </p:xfrm>
        <a:graphic>
          <a:graphicData uri="http://schemas.openxmlformats.org/drawingml/2006/table">
            <a:tbl>
              <a:tblPr firstRow="1" bandRow="1">
                <a:tableStyleId>{69CF1AB2-1976-4502-BF36-3FF5EA218861}</a:tableStyleId>
              </a:tblPr>
              <a:tblGrid>
                <a:gridCol w="478465"/>
                <a:gridCol w="659218"/>
                <a:gridCol w="659219"/>
                <a:gridCol w="637953"/>
                <a:gridCol w="868100"/>
                <a:gridCol w="660591"/>
                <a:gridCol w="660591"/>
                <a:gridCol w="660591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VL</a:t>
                      </a:r>
                    </a:p>
                    <a:p>
                      <a:pPr algn="ctr"/>
                      <a:r>
                        <a:rPr lang="en-GB" sz="1100" dirty="0" smtClean="0"/>
                        <a:t>case</a:t>
                      </a:r>
                      <a:endParaRPr lang="en-GB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Non-VL case</a:t>
                      </a:r>
                      <a:endParaRPr lang="en-GB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Chagas disease</a:t>
                      </a:r>
                      <a:endParaRPr lang="en-GB" sz="1100" dirty="0"/>
                    </a:p>
                  </a:txBody>
                  <a:tcPr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Malaria</a:t>
                      </a:r>
                      <a:endParaRPr lang="en-GB" sz="1100" dirty="0"/>
                    </a:p>
                  </a:txBody>
                  <a:tcPr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Other </a:t>
                      </a:r>
                      <a:r>
                        <a:rPr lang="en-GB" sz="1100" dirty="0" err="1" smtClean="0"/>
                        <a:t>parasitoses</a:t>
                      </a:r>
                      <a:endParaRPr lang="en-GB" sz="1100" dirty="0"/>
                    </a:p>
                  </a:txBody>
                  <a:tcPr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Spanish Blood donors</a:t>
                      </a:r>
                      <a:endParaRPr lang="en-GB" sz="1100" dirty="0"/>
                    </a:p>
                  </a:txBody>
                  <a:tcPr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German Blood donors</a:t>
                      </a:r>
                      <a:endParaRPr lang="en-GB" sz="1100" dirty="0"/>
                    </a:p>
                  </a:txBody>
                  <a:tcPr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Belgian Blood</a:t>
                      </a:r>
                      <a:r>
                        <a:rPr lang="en-GB" sz="1100" baseline="0" dirty="0" smtClean="0"/>
                        <a:t> donors</a:t>
                      </a:r>
                      <a:endParaRPr lang="en-GB" sz="1100" dirty="0"/>
                    </a:p>
                  </a:txBody>
                  <a:tcPr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 smtClean="0"/>
                        <a:t>141</a:t>
                      </a:r>
                      <a:endParaRPr lang="en-GB" sz="1100" dirty="0"/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64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1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5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7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42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3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0</a:t>
                      </a:r>
                      <a:endParaRPr lang="en-GB" sz="11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</a:tr>
            </a:tbl>
          </a:graphicData>
        </a:graphic>
      </p:graphicFrame>
      <p:cxnSp>
        <p:nvCxnSpPr>
          <p:cNvPr id="10" name="Straight Connector 9"/>
          <p:cNvCxnSpPr/>
          <p:nvPr/>
        </p:nvCxnSpPr>
        <p:spPr>
          <a:xfrm>
            <a:off x="1013824" y="3232298"/>
            <a:ext cx="1132055" cy="0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2145879" y="3232298"/>
            <a:ext cx="4152317" cy="0"/>
          </a:xfrm>
          <a:prstGeom prst="line">
            <a:avLst/>
          </a:prstGeom>
          <a:ln w="19050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>
            <a:off x="1594894" y="2764464"/>
            <a:ext cx="0" cy="467834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>
            <a:off x="5082364" y="2410119"/>
            <a:ext cx="0" cy="822179"/>
          </a:xfrm>
          <a:prstGeom prst="straightConnector1">
            <a:avLst/>
          </a:prstGeom>
          <a:ln w="19050">
            <a:solidFill>
              <a:schemeClr val="accent2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>
            <a:off x="3666466" y="4443841"/>
            <a:ext cx="0" cy="1094321"/>
          </a:xfrm>
          <a:prstGeom prst="straightConnector1">
            <a:avLst/>
          </a:prstGeom>
          <a:ln w="19050">
            <a:solidFill>
              <a:schemeClr val="tx1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3719631" y="4930303"/>
            <a:ext cx="1830564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en-GB" sz="1200" dirty="0" smtClean="0"/>
              <a:t>Serological evaluation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564444" y="1022147"/>
            <a:ext cx="5742370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GB" sz="1100" b="1" dirty="0" err="1" smtClean="0"/>
              <a:t>WHOCCl</a:t>
            </a:r>
            <a:r>
              <a:rPr lang="en-GB" sz="1100" b="1" dirty="0" smtClean="0"/>
              <a:t>-ISCIII sample repository National </a:t>
            </a:r>
            <a:r>
              <a:rPr lang="en-GB" sz="1100" b="1" dirty="0" err="1" smtClean="0"/>
              <a:t>Biobank</a:t>
            </a:r>
            <a:r>
              <a:rPr lang="en-GB" sz="1100" b="1" dirty="0" smtClean="0"/>
              <a:t> Register-Section collections C.0000898</a:t>
            </a:r>
            <a:endParaRPr lang="en-GB" sz="1100" dirty="0" smtClean="0"/>
          </a:p>
        </p:txBody>
      </p:sp>
    </p:spTree>
    <p:extLst>
      <p:ext uri="{BB962C8B-B14F-4D97-AF65-F5344CB8AC3E}">
        <p14:creationId xmlns:p14="http://schemas.microsoft.com/office/powerpoint/2010/main" val="24027438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7</TotalTime>
  <Words>166</Words>
  <Application>Microsoft Office PowerPoint</Application>
  <PresentationFormat>A4 Paper (210x297 mm)</PresentationFormat>
  <Paragraphs>8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FIN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sra Cruz</dc:creator>
  <cp:lastModifiedBy>Isra Cruz</cp:lastModifiedBy>
  <cp:revision>28</cp:revision>
  <dcterms:created xsi:type="dcterms:W3CDTF">2016-07-06T07:41:34Z</dcterms:created>
  <dcterms:modified xsi:type="dcterms:W3CDTF">2018-02-07T10:04:13Z</dcterms:modified>
</cp:coreProperties>
</file>